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F04D4-FB67-4A31-A44F-1A13AFCBC5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FD82E-8EAB-4AA8-B58D-A96673CF32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C64F8-EBF9-4198-80B5-511C0B7807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940A6C-2C14-4BAD-A447-96CAEFAD19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1C9AE-F3B0-4A09-957A-7971466D87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7D461-4D67-4BAB-B2BA-A20BF9E67E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F26DE-A3C7-49F3-80D6-DF28D8AC72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6833A-D15F-4582-86E5-451E1B72B8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871C58-D3C6-42C3-BBB9-3B7F667D46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74C35-CD37-40C4-BE0D-DDAD18FFC0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DC9BD0-0DF9-4191-8817-C676320570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132C2-62FD-4378-936F-26B0735D54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78A7B4-881D-4970-A671-CFF29F4655B6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295280" y="914400"/>
          <a:ext cx="6172200" cy="5121360"/>
        </p:xfrm>
        <a:graphic>
          <a:graphicData uri="http://schemas.openxmlformats.org/drawingml/2006/table">
            <a:tbl>
              <a:tblPr/>
              <a:tblGrid>
                <a:gridCol w="762120"/>
                <a:gridCol w="3581280"/>
                <a:gridCol w="1828800"/>
              </a:tblGrid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quence (5</a:t>
                      </a: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’</a:t>
                      </a: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-3</a:t>
                      </a: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’</a:t>
                      </a: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Re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I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TAGTCTCCTGTCCCCGTTTACC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IR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CGCCTCCATTTCGTCGAATCCCC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ettles et al., 20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IR8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CGCCTCCATTTCGTCGAATCCSC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ettles et al., 20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IR8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GCCTCCATTTCGTCGAATCCCK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ettles et al., 20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IR8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CGCCTCCATTTCGTCGAATCACC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ettles et al., 20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IR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GAGAAGCCAACGCCAWCGCCTCYATTTCG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ettles et al., 20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8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D3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GTTTTTGGGTGGTGG(G/C/A)N(G/C/A)NNNGG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Liu and Chen, 2007; 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D3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GTTTTTGGGTGGTGG(G/C/T)N(G/C/T)NNNGG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Liu and Chen, 2007; 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D3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GTTTTTGGGTGGTGG(G/C/A)(G/C/A)N(G/C/A)NNNCC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Liu and Chen, 2007; 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D3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GTTTTTGGGTGGTGG(G/C/T)(G/A/T)N(G/C/T)NNNCG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Liu and Chen, 2007; 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D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GTTTTTGGGTGG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Mu1-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GACGAGCAACGGACGCACCT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Mu2-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GTGAAGCCCTGCTCCCGCACCTA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Mu2-F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GACGGAGATGCGACGGAGAAAAAGG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Mu2-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GGCCGCGGCGAGGTGG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Mu2-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GCGCGGCGACGGAGACAAGAAGA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Emb16-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ACAGAGCAGGACAGGATAG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Emb16-F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CCGCCTGTCTCCTCCT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Emb16-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CCTTCGCCATTCGTACTCAG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Emb16-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GAAAGGGTCATGAAAGAACT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his pa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720">
                      <a:solidFill>
                        <a:srgbClr val="000000"/>
                      </a:solidFill>
                    </a:lnL>
                    <a:lnR w="720">
                      <a:solidFill>
                        <a:srgbClr val="000000"/>
                      </a:solidFill>
                    </a:lnR>
                    <a:lnT w="720">
                      <a:solidFill>
                        <a:srgbClr val="000000"/>
                      </a:solidFill>
                    </a:lnT>
                    <a:lnB w="7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微软用户</cp:lastModifiedBy>
  <dcterms:modified xsi:type="dcterms:W3CDTF">2013-05-27T08:07:54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